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D266D8F-FDFC-42D1-8B35-7B62A47CD6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8E64C36-D140-4AF6-BFFC-4BD7174902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E0101A3-2F7E-4053-86F6-18EEBD316D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A48CC-5982-4D19-8361-518A962EF24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0ED10FB-7C6C-4FA3-AF0E-582F6AD6D0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480D88E-A04B-4FFB-A2F7-61B0F3B73A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D4C0-0973-4091-A47E-81696FEFF8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2691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EDBC68-D227-4D18-968D-6C93ED2FFF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BF21E7B-0ED0-4C8C-8560-E9AE76B0A7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D5814D8-CB0D-479E-B841-1CBC981A97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A48CC-5982-4D19-8361-518A962EF24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A5B3393-D442-45DC-B179-2BA8D1363B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E7D3530-65D9-4B6A-9BB2-68D2851609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D4C0-0973-4091-A47E-81696FEFF8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3682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7C490E9-12BE-46C8-A480-A50F8FD5FA6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8D994B8-59C6-4B81-81B4-B7EE0457B8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889EBC0-34B6-4AE9-B3ED-B434F9C3B8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A48CC-5982-4D19-8361-518A962EF24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35CDD8E-3968-476E-9E8B-C2FF9FEF92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61C95F6-BCC4-40CF-A52B-4D86E07E6E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D4C0-0973-4091-A47E-81696FEFF8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63634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139D86F-1226-41D5-8E09-79FC966231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61E8DCD-213E-4A9D-BC52-55303757169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8448A84-B70A-4816-8A87-83DEE56DF1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A48CC-5982-4D19-8361-518A962EF24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57EB784-EB1C-4D0B-A20E-A6497F5D64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4D776B7-709C-4765-BB2A-9016972627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D4C0-0973-4091-A47E-81696FEFF8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5224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3566E9-5E6A-4FA1-A5B4-124AF5B1D4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AB9BEAA-79C2-4DEF-9920-B645AE3584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C52701E-C99F-4BD8-AA34-9249FBAB46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A48CC-5982-4D19-8361-518A962EF24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70A8292-823B-4795-ACED-91B94F9CDB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E313534-11A1-49FA-9491-E9BAD66550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D4C0-0973-4091-A47E-81696FEFF8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4939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B596869-79AF-43F0-98BC-736E51905C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717A643-8707-46DB-A203-8B9D5C891EB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6758F19-6034-44C2-B4D8-AA871EF2B9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470483D-5FEB-4B98-A778-2E1B29362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A48CC-5982-4D19-8361-518A962EF24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FA9FE97-6A42-4337-B004-2C96F59896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912B941-231D-4BEC-B474-545888FE3C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D4C0-0973-4091-A47E-81696FEFF8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538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FABE3F5-21D7-4D24-B61A-3330C45C0F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E5B5D35-F342-45D0-BD9B-1D96F8CF5A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CAA7ABC-2619-4AE5-B893-8625CD4300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8691093-E969-44A1-AF15-5A5EE3846A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69782D3-022E-49BB-8EFC-2B3867DB5CD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86AF8DA-E2C6-4834-9C32-C4449A08DB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A48CC-5982-4D19-8361-518A962EF24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56870EC-4430-4548-82A5-F82B575BA7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FF4B755-071B-4A45-85D6-A268BCEE69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D4C0-0973-4091-A47E-81696FEFF8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05244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1D8747-600E-4B8D-9A8B-48CA7C31E7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FED413C-7A3F-4B40-A8F0-F5B8AA5DE8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A48CC-5982-4D19-8361-518A962EF24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4C29D1D-60F0-48CE-9AD7-4CC58BC168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C8E75C5-DCD6-4944-AE27-5D2262DFCF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D4C0-0973-4091-A47E-81696FEFF8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264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966ECB3-7CCB-40B4-AC0D-2F801680F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A48CC-5982-4D19-8361-518A962EF24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63A6FC3-3483-48FC-A403-84EE8C9EB3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0158AAC-A049-47D1-B2C3-21F0632C0A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D4C0-0973-4091-A47E-81696FEFF8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9011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0387941-463C-4DF0-BBBB-2A0FC11F36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22AB3BE-4B40-436B-8B7E-B78985DE11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2E904D9-E01C-4772-B2E4-488A268EEF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8C475F5-C5B2-4BB9-A5C2-6C188415C7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A48CC-5982-4D19-8361-518A962EF24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2F979DF-8525-4385-A6D3-2FCB0913A6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D5313AB-22AB-4F56-9095-75D73A1DC8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D4C0-0973-4091-A47E-81696FEFF8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61978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FFA18DA-C94D-4E27-93C0-F52AA4C4C2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39FB480-EBB0-4CB4-9579-C42A8057224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195AE49-9D1B-4234-9CAA-6C3F68AF03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23429B1-04F0-45D5-8271-045598DFB8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A48CC-5982-4D19-8361-518A962EF24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4658479-7507-4A6F-9F64-4F03BC0CC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3D0C674-B895-422E-892A-83CBB09FBA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D4C0-0973-4091-A47E-81696FEFF8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7920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E0B58F8-CBE4-41F9-AB00-B583C18541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1C42220-5E9D-4DE2-B3E6-FE955E75D8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AEAE127-96F3-46AB-9914-C04595BDF1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1A48CC-5982-4D19-8361-518A962EF24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756DE31-189E-4DB7-A3EA-BE75C56C0D8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BF000BA-3B89-4675-8049-F98537603C2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FD4C0-0973-4091-A47E-81696FEFF8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51694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DC52A84-0F04-483E-A44B-76C4ADB4DDBA}"/>
              </a:ext>
            </a:extLst>
          </p:cNvPr>
          <p:cNvSpPr txBox="1"/>
          <p:nvPr/>
        </p:nvSpPr>
        <p:spPr>
          <a:xfrm>
            <a:off x="136967" y="153810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Fig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E5C3B4B3-7BEE-48E6-B2C6-77A3E42482D3}"/>
              </a:ext>
            </a:extLst>
          </p:cNvPr>
          <p:cNvGrpSpPr/>
          <p:nvPr/>
        </p:nvGrpSpPr>
        <p:grpSpPr>
          <a:xfrm>
            <a:off x="1416951" y="226413"/>
            <a:ext cx="4257698" cy="6560566"/>
            <a:chOff x="930775" y="372862"/>
            <a:chExt cx="4257698" cy="6560566"/>
          </a:xfrm>
        </p:grpSpPr>
        <p:pic>
          <p:nvPicPr>
            <p:cNvPr id="25" name="図 24">
              <a:extLst>
                <a:ext uri="{FF2B5EF4-FFF2-40B4-BE49-F238E27FC236}">
                  <a16:creationId xmlns:a16="http://schemas.microsoft.com/office/drawing/2014/main" id="{D41188F5-BA81-466C-981A-CCA8CC1C9D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46" r="39105" b="7077"/>
            <a:stretch/>
          </p:blipFill>
          <p:spPr>
            <a:xfrm>
              <a:off x="2130571" y="372862"/>
              <a:ext cx="3057902" cy="4300812"/>
            </a:xfrm>
            <a:prstGeom prst="rect">
              <a:avLst/>
            </a:prstGeom>
          </p:spPr>
        </p:pic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20C75283-C0A2-4E93-8D04-BAFF4C2F1B0B}"/>
                </a:ext>
              </a:extLst>
            </p:cNvPr>
            <p:cNvSpPr txBox="1"/>
            <p:nvPr/>
          </p:nvSpPr>
          <p:spPr>
            <a:xfrm rot="16200000">
              <a:off x="310733" y="2780284"/>
              <a:ext cx="1947969" cy="70788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. of identified </a:t>
              </a:r>
            </a:p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od plant taxa</a:t>
              </a: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05B4017D-93F6-4694-86E4-4CCF78921B2B}"/>
                </a:ext>
              </a:extLst>
            </p:cNvPr>
            <p:cNvSpPr txBox="1"/>
            <p:nvPr/>
          </p:nvSpPr>
          <p:spPr>
            <a:xfrm rot="18517826">
              <a:off x="1292816" y="5230928"/>
              <a:ext cx="1915909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ocal and NCBI </a:t>
              </a:r>
            </a:p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ults of rbcL</a:t>
              </a: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50988E56-880A-4581-B580-005DBEF87EBE}"/>
                </a:ext>
              </a:extLst>
            </p:cNvPr>
            <p:cNvSpPr txBox="1"/>
            <p:nvPr/>
          </p:nvSpPr>
          <p:spPr>
            <a:xfrm rot="18517826">
              <a:off x="2301983" y="5196637"/>
              <a:ext cx="1858201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cal and NCBI </a:t>
              </a:r>
            </a:p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ults of ITS2</a:t>
              </a: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03FE49B5-E96D-4F0A-8435-6B02FD4557FF}"/>
                </a:ext>
              </a:extLst>
            </p:cNvPr>
            <p:cNvSpPr txBox="1"/>
            <p:nvPr/>
          </p:nvSpPr>
          <p:spPr>
            <a:xfrm>
              <a:off x="1638534" y="1409808"/>
              <a:ext cx="448842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.0</a:t>
              </a: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4CF78FBF-909D-4F28-B028-6537382D7C4C}"/>
                </a:ext>
              </a:extLst>
            </p:cNvPr>
            <p:cNvSpPr txBox="1"/>
            <p:nvPr/>
          </p:nvSpPr>
          <p:spPr>
            <a:xfrm>
              <a:off x="1639015" y="2908346"/>
              <a:ext cx="466008" cy="38048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72000" tIns="36000" rIns="72000" bIns="36000" rtlCol="0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.0</a:t>
              </a: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61D33EF7-9525-4B7E-9240-D0393092E813}"/>
                </a:ext>
              </a:extLst>
            </p:cNvPr>
            <p:cNvSpPr txBox="1"/>
            <p:nvPr/>
          </p:nvSpPr>
          <p:spPr>
            <a:xfrm rot="18517826">
              <a:off x="3108442" y="5359118"/>
              <a:ext cx="2225291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mbined rbcL and ITS2 database and NCBI results</a:t>
              </a: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3CD28A1C-D7FE-4E21-8A4B-E32645E99A66}"/>
                </a:ext>
              </a:extLst>
            </p:cNvPr>
            <p:cNvSpPr txBox="1"/>
            <p:nvPr/>
          </p:nvSpPr>
          <p:spPr>
            <a:xfrm>
              <a:off x="1659983" y="4414718"/>
              <a:ext cx="466008" cy="38048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72000" tIns="36000" rIns="72000" bIns="36000" rtlCol="0">
              <a:spAutoFit/>
            </a:bodyPr>
            <a:lstStyle/>
            <a:p>
              <a:pPr algn="ctr"/>
              <a:r>
                <a:rPr lang="en-US" altLang="ja-JP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</a:p>
          </p:txBody>
        </p:sp>
        <p:sp>
          <p:nvSpPr>
            <p:cNvPr id="19" name="正方形/長方形 18">
              <a:extLst>
                <a:ext uri="{FF2B5EF4-FFF2-40B4-BE49-F238E27FC236}">
                  <a16:creationId xmlns:a16="http://schemas.microsoft.com/office/drawing/2014/main" id="{68AAD190-8691-4A38-B27F-2E9DE0261AF9}"/>
                </a:ext>
              </a:extLst>
            </p:cNvPr>
            <p:cNvSpPr/>
            <p:nvPr/>
          </p:nvSpPr>
          <p:spPr>
            <a:xfrm>
              <a:off x="2537889" y="1397289"/>
              <a:ext cx="350776" cy="3507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A41F1D42-8316-4602-8FD5-862C90C0176E}"/>
                </a:ext>
              </a:extLst>
            </p:cNvPr>
            <p:cNvSpPr/>
            <p:nvPr/>
          </p:nvSpPr>
          <p:spPr>
            <a:xfrm>
              <a:off x="3525705" y="1681390"/>
              <a:ext cx="350776" cy="3507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25AEB051-9F67-4D83-AC1F-45B26E5389B7}"/>
                </a:ext>
              </a:extLst>
            </p:cNvPr>
            <p:cNvSpPr/>
            <p:nvPr/>
          </p:nvSpPr>
          <p:spPr>
            <a:xfrm>
              <a:off x="4474878" y="1397289"/>
              <a:ext cx="350776" cy="3507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B655B71C-8448-4170-8506-4C253674F56A}"/>
                </a:ext>
              </a:extLst>
            </p:cNvPr>
            <p:cNvSpPr txBox="1"/>
            <p:nvPr/>
          </p:nvSpPr>
          <p:spPr>
            <a:xfrm>
              <a:off x="2521257" y="1068958"/>
              <a:ext cx="367408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3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kumimoji="1" lang="ja-JP" altLang="en-US" sz="3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4A5CFA5D-D123-4617-99F3-0CB514B0A68D}"/>
                </a:ext>
              </a:extLst>
            </p:cNvPr>
            <p:cNvSpPr txBox="1"/>
            <p:nvPr/>
          </p:nvSpPr>
          <p:spPr>
            <a:xfrm>
              <a:off x="3467028" y="1068958"/>
              <a:ext cx="389850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3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kumimoji="1" lang="ja-JP" altLang="en-US" sz="3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F81F712A-CB9A-4496-8E21-A3BC092194C4}"/>
                </a:ext>
              </a:extLst>
            </p:cNvPr>
            <p:cNvSpPr txBox="1"/>
            <p:nvPr/>
          </p:nvSpPr>
          <p:spPr>
            <a:xfrm>
              <a:off x="4467052" y="1062111"/>
              <a:ext cx="367408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3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kumimoji="1" lang="ja-JP" altLang="en-US" sz="3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E0AC2F7-2D88-4807-A861-1C68D104B75C}"/>
              </a:ext>
            </a:extLst>
          </p:cNvPr>
          <p:cNvSpPr txBox="1"/>
          <p:nvPr/>
        </p:nvSpPr>
        <p:spPr>
          <a:xfrm>
            <a:off x="6065335" y="1067909"/>
            <a:ext cx="5070873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Fig. Comparison of number of plant taxa per fecal sample identified by querying local and NCBI databases for </a:t>
            </a:r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bcL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quences, local and NCBI queries for ITS2 sequences, and queries using combined </a:t>
            </a:r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bcL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ITS2 local database as well as NCBI results.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umbers of plant taxa per fecal sample identified by the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bcL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al database, ITS2 local database, and a combination of the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bcL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ITS2 local databases are presented as boxplots. Each box delimits values between 25% and 75% of the group. The bold horizontal line represents the median of the group. Whiskers are drawn for obtained values that differ least from the median ± 1.5 interquartile ranges. Different letters indicate statistically significant differences (Steel-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wass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, P&lt;0.05) between groups.</a:t>
            </a:r>
            <a:endParaRPr lang="ja-JP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84464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175</Words>
  <Application>Microsoft Office PowerPoint</Application>
  <PresentationFormat>ワイド画面</PresentationFormat>
  <Paragraphs>1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Windows ユーザー</dc:creator>
  <cp:lastModifiedBy>Windows ユーザー</cp:lastModifiedBy>
  <cp:revision>13</cp:revision>
  <dcterms:created xsi:type="dcterms:W3CDTF">2021-11-29T03:07:24Z</dcterms:created>
  <dcterms:modified xsi:type="dcterms:W3CDTF">2021-12-20T02:02:53Z</dcterms:modified>
</cp:coreProperties>
</file>